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12192000" cy="7772400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40445"/>
    <a:srgbClr val="3C1C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 autoAdjust="0"/>
    <p:restoredTop sz="98287" autoAdjust="0"/>
  </p:normalViewPr>
  <p:slideViewPr>
    <p:cSldViewPr snapToGrid="0">
      <p:cViewPr>
        <p:scale>
          <a:sx n="70" d="100"/>
          <a:sy n="70" d="100"/>
        </p:scale>
        <p:origin x="-1099" y="-413"/>
      </p:cViewPr>
      <p:guideLst>
        <p:guide orient="horz" pos="2449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FABE69-1E0A-4574-A649-E0734A7515EE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79425" y="744538"/>
            <a:ext cx="5840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40363" cy="44688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21F534-534B-4480-8E10-8B09B761BC8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140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72013"/>
            <a:ext cx="9144000" cy="270594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82311"/>
            <a:ext cx="9144000" cy="187653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909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087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13811"/>
            <a:ext cx="2628900" cy="658674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13811"/>
            <a:ext cx="7734300" cy="658674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285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593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937703"/>
            <a:ext cx="10515600" cy="323310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201393"/>
            <a:ext cx="10515600" cy="1700212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195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2069043"/>
            <a:ext cx="5181600" cy="49315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2069043"/>
            <a:ext cx="5181600" cy="49315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068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13809"/>
            <a:ext cx="10515600" cy="150230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2" y="1905320"/>
            <a:ext cx="51577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2" y="2839085"/>
            <a:ext cx="5157787" cy="41758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05320"/>
            <a:ext cx="51831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39085"/>
            <a:ext cx="5183187" cy="41758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01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560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5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7" y="1119083"/>
            <a:ext cx="6172201" cy="552344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8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7" y="1119083"/>
            <a:ext cx="6172201" cy="552344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0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413809"/>
            <a:ext cx="10515600" cy="150230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2069043"/>
            <a:ext cx="10515600" cy="49315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7203863"/>
            <a:ext cx="27432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7203863"/>
            <a:ext cx="41148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7203863"/>
            <a:ext cx="27432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043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43544" y="1212850"/>
            <a:ext cx="12235544" cy="5549229"/>
            <a:chOff x="-43544" y="1212850"/>
            <a:chExt cx="12235544" cy="5549229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6515"/>
            <a:stretch/>
          </p:blipFill>
          <p:spPr bwMode="auto">
            <a:xfrm>
              <a:off x="52114" y="1212850"/>
              <a:ext cx="12139886" cy="55492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 rot="16200000">
              <a:off x="903503" y="3352779"/>
              <a:ext cx="10415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A 2039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 rot="16200000">
              <a:off x="1285393" y="3362781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B 2039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1796989" y="3395483"/>
              <a:ext cx="1126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L 87119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2296907" y="3352779"/>
              <a:ext cx="10415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A 2089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2700569" y="3362782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B 2089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3255752" y="3362782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R 3637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3701197" y="3352779"/>
              <a:ext cx="10415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A 2078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4148403" y="3362781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B 2078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4649156" y="3362782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R 4395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5127259" y="3352779"/>
              <a:ext cx="10415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A 2043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5585351" y="3362782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B 2043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6075218" y="3362782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R 3473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6575093" y="3352779"/>
              <a:ext cx="10415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A 2047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7011413" y="3362782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B 2047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7490394" y="3362781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R 2740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7990269" y="3352779"/>
              <a:ext cx="10415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A 2048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8437475" y="3362781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B 2048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8916456" y="3362781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R 3494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9405445" y="3352779"/>
              <a:ext cx="10415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A 2092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9830879" y="3362781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B 2092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10353403" y="3362781"/>
              <a:ext cx="10615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CPR 3762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-43544" y="4279399"/>
              <a:ext cx="13035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LG08_RFQI1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-32662" y="4497115"/>
              <a:ext cx="13035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LG08_RFQI4</a:t>
              </a:r>
              <a:endParaRPr lang="en-I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400711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0</TotalTime>
  <Words>44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Saxena, Rachit (ICRISAT-IN)</cp:lastModifiedBy>
  <cp:revision>158</cp:revision>
  <dcterms:created xsi:type="dcterms:W3CDTF">2014-11-24T17:11:55Z</dcterms:created>
  <dcterms:modified xsi:type="dcterms:W3CDTF">2016-08-01T03:51:22Z</dcterms:modified>
</cp:coreProperties>
</file>